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5903"/>
  </p:normalViewPr>
  <p:slideViewPr>
    <p:cSldViewPr snapToGrid="0">
      <p:cViewPr varScale="1">
        <p:scale>
          <a:sx n="90" d="100"/>
          <a:sy n="90" d="100"/>
        </p:scale>
        <p:origin x="232" y="7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EAE56E-B36C-63FE-6387-1F6279EF6D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4DE04FE-8465-2146-F927-3D1CEB82B2D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EB1E1B-10C3-FB62-791E-5ADB8EC0CE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E4D3E-2E21-1349-984B-C7D38D8D3DC5}" type="datetimeFigureOut">
              <a:rPr lang="en-GB" smtClean="0"/>
              <a:t>16/08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337750-C70F-5B27-FF73-CDA64C6464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CC851C-0DF4-CC42-FAD3-E667AF0C46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A0066-B430-B24F-8CA9-B60840481E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10272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9B8417-C45F-87F9-F676-2FBAF5A8FF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DA1D6C-0C40-8861-89F4-7A7599A77F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75155A-1408-2966-28B8-B1EA07929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E4D3E-2E21-1349-984B-C7D38D8D3DC5}" type="datetimeFigureOut">
              <a:rPr lang="en-GB" smtClean="0"/>
              <a:t>16/08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D49E22-4951-0407-280E-93E1B02DD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7E7EC8-3DAA-1AF9-8F7C-95D168B4FE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A0066-B430-B24F-8CA9-B60840481E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8462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143654A-65F1-1BA4-8611-0C771C6FD3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F1E81A-9FBD-FA08-D828-F6FBDFF45C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6F3DC3-A379-12EB-89C9-5B86DF7B6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E4D3E-2E21-1349-984B-C7D38D8D3DC5}" type="datetimeFigureOut">
              <a:rPr lang="en-GB" smtClean="0"/>
              <a:t>16/08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A40B02-0930-BE5C-DF82-EED04CBA63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68C436-97AF-E87F-6C41-37D657B1E7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A0066-B430-B24F-8CA9-B60840481E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34119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739091-F2C7-FA05-A944-83058A703F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B04355-8A82-E8FC-ABF6-26A0E13270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6A2599-20F2-1FC2-B01A-FE4C578066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E4D3E-2E21-1349-984B-C7D38D8D3DC5}" type="datetimeFigureOut">
              <a:rPr lang="en-GB" smtClean="0"/>
              <a:t>16/08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3938D8-8693-F631-D2A6-E37BBD16E9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CB3E0D-646A-3706-8978-066E37B540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A0066-B430-B24F-8CA9-B60840481E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732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4A7D09-D363-045E-A332-4FA1B78697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5C3B67-67EF-F388-2DE3-80796C409A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E50CD9-D25B-10DD-44B8-15311B8454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E4D3E-2E21-1349-984B-C7D38D8D3DC5}" type="datetimeFigureOut">
              <a:rPr lang="en-GB" smtClean="0"/>
              <a:t>16/08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29CD11-78D4-C51F-CFBB-B5D9924AA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BC125C-5BD5-B3DB-514D-5FB6EB7628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A0066-B430-B24F-8CA9-B60840481E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78387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E50D90-B4F1-3D38-814D-9B4F006782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E0129C-6F24-088A-64AE-29903C1AEA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646443-DF9E-1E3F-7299-89930ADB5E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54C422-CA79-F39B-9F69-7BAC5CE742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E4D3E-2E21-1349-984B-C7D38D8D3DC5}" type="datetimeFigureOut">
              <a:rPr lang="en-GB" smtClean="0"/>
              <a:t>16/08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697981-934E-CAC3-958D-A5C7F58B9B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E35AA7-4B93-F87D-C2BF-433647DB63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A0066-B430-B24F-8CA9-B60840481E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4873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D0ED1B-73AE-09C1-BE96-6E9C6B4FF6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328810-435E-F7E8-8EC4-DEAFA7578E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3315FE-D857-CA42-D448-2FA10F7ABD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8EFAA4B-7BD8-B677-1970-A184CE9A0E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23F9E17-3D16-1263-3CC0-FEFB626CDB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9FAE844-002D-F9C6-E845-7B260E238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E4D3E-2E21-1349-984B-C7D38D8D3DC5}" type="datetimeFigureOut">
              <a:rPr lang="en-GB" smtClean="0"/>
              <a:t>16/08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01BF792-2A58-F87D-7125-BE6B38CF1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4F25592-9886-72EB-30FC-64AC05A62A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A0066-B430-B24F-8CA9-B60840481E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0519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E39E72-3172-AD6F-A3D8-F65B9DD137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9BAF413-6AA4-9B90-9B9D-A864FFACF5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E4D3E-2E21-1349-984B-C7D38D8D3DC5}" type="datetimeFigureOut">
              <a:rPr lang="en-GB" smtClean="0"/>
              <a:t>16/08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A4EA5C1-F2AD-BADB-DFA9-2963821A03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1F49A6A-7781-3D33-0A20-8475BF6129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A0066-B430-B24F-8CA9-B60840481E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5250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278966A-D790-6220-C0BD-92987E43B8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E4D3E-2E21-1349-984B-C7D38D8D3DC5}" type="datetimeFigureOut">
              <a:rPr lang="en-GB" smtClean="0"/>
              <a:t>16/08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2D19588-5614-CA1D-AF33-C13875AF2F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6132E7E-F4A8-7064-9D6C-929F60977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A0066-B430-B24F-8CA9-B60840481E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0223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72E32B-5428-03DF-3ABA-0451050379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25E289-8338-5C6B-F5CF-9CFE86D6B4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8C1D72-2448-4FCC-4352-7EED9049ED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BB20B4-025A-BD1F-D9B7-4008F58166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E4D3E-2E21-1349-984B-C7D38D8D3DC5}" type="datetimeFigureOut">
              <a:rPr lang="en-GB" smtClean="0"/>
              <a:t>16/08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484789-EDDA-9D8A-E872-E8E50F9FE5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103881-6B98-4056-23F2-AFC0EF57D2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A0066-B430-B24F-8CA9-B60840481E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9886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69CC6B-F919-C22F-51FB-16F09CF1AF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0197FB5-82AA-92DB-DD63-9CD2182D5A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C699C1-7FF8-9F8C-8F73-021FCFE461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08B41C0-7E47-C9E0-E328-116B4297E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E4D3E-2E21-1349-984B-C7D38D8D3DC5}" type="datetimeFigureOut">
              <a:rPr lang="en-GB" smtClean="0"/>
              <a:t>16/08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5F3A2F-5358-0C29-F21B-5A07A32B74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34F080-57DC-093D-25B5-CD2742E9D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A0066-B430-B24F-8CA9-B60840481E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5294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6704451-F90A-94EF-1A7B-4E0DDF9A71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382B62-30BB-465B-9EF0-DC8FE46E3F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B93C2D-D1CC-8812-8B83-ABB4DABF3E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EE4D3E-2E21-1349-984B-C7D38D8D3DC5}" type="datetimeFigureOut">
              <a:rPr lang="en-GB" smtClean="0"/>
              <a:t>16/08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97DD63-9E5D-9143-D010-47698D7D35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6CAF7F-004B-FB06-FB41-D0554A2F95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FA0066-B430-B24F-8CA9-B60840481E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27459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983F6E6-7157-6FD0-9E32-72EB1D78833D}"/>
              </a:ext>
            </a:extLst>
          </p:cNvPr>
          <p:cNvSpPr txBox="1"/>
          <p:nvPr/>
        </p:nvSpPr>
        <p:spPr>
          <a:xfrm>
            <a:off x="89211" y="133814"/>
            <a:ext cx="76564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EV3i Western blot of WT organoids in absence or presence of Heat Shock</a:t>
            </a:r>
          </a:p>
          <a:p>
            <a:endParaRPr lang="en-GB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DF2E008-86B4-A238-2374-20EA90207B98}"/>
              </a:ext>
            </a:extLst>
          </p:cNvPr>
          <p:cNvSpPr txBox="1"/>
          <p:nvPr/>
        </p:nvSpPr>
        <p:spPr>
          <a:xfrm>
            <a:off x="249835" y="1959933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HSP2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289FDE4-A5C4-6E5C-B834-0FF7BE72D5CE}"/>
              </a:ext>
            </a:extLst>
          </p:cNvPr>
          <p:cNvSpPr txBox="1"/>
          <p:nvPr/>
        </p:nvSpPr>
        <p:spPr>
          <a:xfrm>
            <a:off x="6127461" y="1964287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APDH</a:t>
            </a:r>
          </a:p>
        </p:txBody>
      </p:sp>
      <p:pic>
        <p:nvPicPr>
          <p:cNvPr id="3" name="Picture 2" descr="A picture containing white&#10;&#10;Description automatically generated">
            <a:extLst>
              <a:ext uri="{FF2B5EF4-FFF2-40B4-BE49-F238E27FC236}">
                <a16:creationId xmlns:a16="http://schemas.microsoft.com/office/drawing/2014/main" id="{EADB760C-881C-20F6-A186-5731C6F5C76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520" r="33963"/>
          <a:stretch/>
        </p:blipFill>
        <p:spPr>
          <a:xfrm>
            <a:off x="6208458" y="2385148"/>
            <a:ext cx="2884669" cy="4320000"/>
          </a:xfrm>
          <a:prstGeom prst="rect">
            <a:avLst/>
          </a:prstGeom>
        </p:spPr>
      </p:pic>
      <p:pic>
        <p:nvPicPr>
          <p:cNvPr id="6" name="Picture 5" descr="A close-up of a person's face&#10;&#10;Description automatically generated with medium confidence">
            <a:extLst>
              <a:ext uri="{FF2B5EF4-FFF2-40B4-BE49-F238E27FC236}">
                <a16:creationId xmlns:a16="http://schemas.microsoft.com/office/drawing/2014/main" id="{EBAFE9B0-E9FF-9342-88A2-75C9A69B73C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7269" r="40231"/>
          <a:stretch/>
        </p:blipFill>
        <p:spPr>
          <a:xfrm>
            <a:off x="214784" y="2385148"/>
            <a:ext cx="2754000" cy="4320000"/>
          </a:xfrm>
          <a:prstGeom prst="rect">
            <a:avLst/>
          </a:prstGeom>
        </p:spPr>
      </p:pic>
      <p:pic>
        <p:nvPicPr>
          <p:cNvPr id="12" name="Picture 11" descr="A picture containing text, dark, night sky&#10;&#10;Description automatically generated">
            <a:extLst>
              <a:ext uri="{FF2B5EF4-FFF2-40B4-BE49-F238E27FC236}">
                <a16:creationId xmlns:a16="http://schemas.microsoft.com/office/drawing/2014/main" id="{B19C7E8D-26EC-9BBC-162B-A0C3A5B497A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5046" r="37454"/>
          <a:stretch/>
        </p:blipFill>
        <p:spPr>
          <a:xfrm>
            <a:off x="3049621" y="2385148"/>
            <a:ext cx="3078000" cy="4320000"/>
          </a:xfrm>
          <a:prstGeom prst="rect">
            <a:avLst/>
          </a:prstGeom>
        </p:spPr>
      </p:pic>
      <p:pic>
        <p:nvPicPr>
          <p:cNvPr id="14" name="Picture 13" descr="A picture containing text, dark, night sky&#10;&#10;Description automatically generated">
            <a:extLst>
              <a:ext uri="{FF2B5EF4-FFF2-40B4-BE49-F238E27FC236}">
                <a16:creationId xmlns:a16="http://schemas.microsoft.com/office/drawing/2014/main" id="{B87DFEEC-5C6B-3478-2252-DB627ED58C0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1609" r="31863"/>
          <a:stretch/>
        </p:blipFill>
        <p:spPr>
          <a:xfrm>
            <a:off x="9177000" y="2385148"/>
            <a:ext cx="3015000" cy="4320000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57A99ADF-C280-A16E-5839-F8E058EA6714}"/>
              </a:ext>
            </a:extLst>
          </p:cNvPr>
          <p:cNvSpPr/>
          <p:nvPr/>
        </p:nvSpPr>
        <p:spPr>
          <a:xfrm>
            <a:off x="6963159" y="5004940"/>
            <a:ext cx="1052513" cy="4429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3A7571D-6AF1-2D1F-DF58-ADFDED60801C}"/>
              </a:ext>
            </a:extLst>
          </p:cNvPr>
          <p:cNvSpPr/>
          <p:nvPr/>
        </p:nvSpPr>
        <p:spPr>
          <a:xfrm>
            <a:off x="748691" y="5004939"/>
            <a:ext cx="1052513" cy="4429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5EAA50F-1A61-2606-E963-B6A48E3409A5}"/>
              </a:ext>
            </a:extLst>
          </p:cNvPr>
          <p:cNvSpPr txBox="1"/>
          <p:nvPr/>
        </p:nvSpPr>
        <p:spPr>
          <a:xfrm>
            <a:off x="8630234" y="133814"/>
            <a:ext cx="3284938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Lanes:</a:t>
            </a:r>
          </a:p>
          <a:p>
            <a:pPr marL="342900" indent="-342900">
              <a:buAutoNum type="arabicPeriod"/>
            </a:pPr>
            <a:r>
              <a:rPr lang="en-GB" sz="1400" dirty="0"/>
              <a:t>WT organoids</a:t>
            </a:r>
          </a:p>
          <a:p>
            <a:pPr marL="342900" indent="-342900">
              <a:buAutoNum type="arabicPeriod"/>
            </a:pPr>
            <a:r>
              <a:rPr lang="en-GB" sz="1400" dirty="0"/>
              <a:t>WT organoids + HS</a:t>
            </a:r>
          </a:p>
          <a:p>
            <a:pPr marL="342900" indent="-342900">
              <a:buAutoNum type="arabicPeriod"/>
            </a:pPr>
            <a:r>
              <a:rPr lang="en-GB" sz="1400" dirty="0"/>
              <a:t>(not used) WT organoids + BVDU </a:t>
            </a:r>
          </a:p>
          <a:p>
            <a:pPr marL="342900" indent="-342900">
              <a:buAutoNum type="arabicPeriod"/>
            </a:pPr>
            <a:r>
              <a:rPr lang="en-GB" sz="1400" dirty="0"/>
              <a:t>(not used) WT organoids + BVDU + HS</a:t>
            </a:r>
          </a:p>
        </p:txBody>
      </p:sp>
    </p:spTree>
    <p:extLst>
      <p:ext uri="{BB962C8B-B14F-4D97-AF65-F5344CB8AC3E}">
        <p14:creationId xmlns:p14="http://schemas.microsoft.com/office/powerpoint/2010/main" val="35134874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42</Words>
  <Application>Microsoft Macintosh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ne van Neerven</dc:creator>
  <cp:lastModifiedBy>Sanne van Neerven</cp:lastModifiedBy>
  <cp:revision>5</cp:revision>
  <dcterms:created xsi:type="dcterms:W3CDTF">2022-08-11T15:09:12Z</dcterms:created>
  <dcterms:modified xsi:type="dcterms:W3CDTF">2022-08-16T13:18:52Z</dcterms:modified>
</cp:coreProperties>
</file>